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4"/>
  </p:sldMasterIdLst>
  <p:notesMasterIdLst>
    <p:notesMasterId r:id="rId6"/>
  </p:notesMasterIdLst>
  <p:sldIdLst>
    <p:sldId id="318" r:id="rId5"/>
  </p:sldIdLst>
  <p:sldSz cx="18288000" cy="2743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F4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3" d="100"/>
          <a:sy n="33" d="100"/>
        </p:scale>
        <p:origin x="2196" y="-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ad.ufl.edu\ifas\GCREC\groups\S-Lee-Lab\YoonJeong\2023_09_26_qRT-PCR_Ca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ad.ufl.edu\ifas\GCREC\groups\S-Lee-Lab\YoonJeong\2023_09_26_qRT-PCR_Ca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uflorida-my.sharepoint.com/personal/yoonjeon_jang_ufl_edu/Documents/2)%20Paper_Yoonjeong%20Jang/Brilliance_PNAS/FaRCa1_fig_revised_JYJ/RNAi/qRT-PCR_FaRca1-O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23_09_26_bar chart (2)'!$C$13:$C$14</c:f>
              <c:strCache>
                <c:ptCount val="2"/>
                <c:pt idx="0">
                  <c:v>160</c:v>
                </c:pt>
                <c:pt idx="1">
                  <c:v>E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23_09_26_bar chart (2)'!$E$15:$E$17</c:f>
                <c:numCache>
                  <c:formatCode>General</c:formatCode>
                  <c:ptCount val="3"/>
                  <c:pt idx="0">
                    <c:v>0.24742522185429228</c:v>
                  </c:pt>
                  <c:pt idx="1">
                    <c:v>0.34657382413995486</c:v>
                  </c:pt>
                  <c:pt idx="2">
                    <c:v>0.343709515113212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_09_26_bar chart (2)'!$B$15:$B$17</c:f>
              <c:strCache>
                <c:ptCount val="3"/>
                <c:pt idx="0">
                  <c:v>ca1ca1</c:v>
                </c:pt>
                <c:pt idx="1">
                  <c:v>Ca1ca1</c:v>
                </c:pt>
                <c:pt idx="2">
                  <c:v>Ca1Ca1</c:v>
                </c:pt>
              </c:strCache>
            </c:strRef>
          </c:cat>
          <c:val>
            <c:numRef>
              <c:f>'2023_09_26_bar chart (2)'!$C$15:$C$17</c:f>
              <c:numCache>
                <c:formatCode>General</c:formatCode>
                <c:ptCount val="3"/>
                <c:pt idx="0">
                  <c:v>1.0318307201801955</c:v>
                </c:pt>
                <c:pt idx="1">
                  <c:v>1.5662972466503304</c:v>
                </c:pt>
                <c:pt idx="2">
                  <c:v>1.07315197743631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63-41E0-886D-85AC9AD1C7B4}"/>
            </c:ext>
          </c:extLst>
        </c:ser>
        <c:ser>
          <c:idx val="1"/>
          <c:order val="1"/>
          <c:tx>
            <c:strRef>
              <c:f>'2023_09_26_bar chart (2)'!$D$13:$D$14</c:f>
              <c:strCache>
                <c:ptCount val="2"/>
                <c:pt idx="0">
                  <c:v>160</c:v>
                </c:pt>
                <c:pt idx="1">
                  <c:v>Targe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23_09_26_bar chart (2)'!$F$15:$F$17</c:f>
                <c:numCache>
                  <c:formatCode>General</c:formatCode>
                  <c:ptCount val="3"/>
                  <c:pt idx="0">
                    <c:v>0.13110850381854197</c:v>
                  </c:pt>
                  <c:pt idx="1">
                    <c:v>0.1277786361022035</c:v>
                  </c:pt>
                  <c:pt idx="2">
                    <c:v>0.145658990918631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_09_26_bar chart (2)'!$B$15:$B$17</c:f>
              <c:strCache>
                <c:ptCount val="3"/>
                <c:pt idx="0">
                  <c:v>ca1ca1</c:v>
                </c:pt>
                <c:pt idx="1">
                  <c:v>Ca1ca1</c:v>
                </c:pt>
                <c:pt idx="2">
                  <c:v>Ca1Ca1</c:v>
                </c:pt>
              </c:strCache>
            </c:strRef>
          </c:cat>
          <c:val>
            <c:numRef>
              <c:f>'2023_09_26_bar chart (2)'!$D$15:$D$17</c:f>
              <c:numCache>
                <c:formatCode>General</c:formatCode>
                <c:ptCount val="3"/>
                <c:pt idx="0">
                  <c:v>0.61835558298245175</c:v>
                </c:pt>
                <c:pt idx="1">
                  <c:v>1.0576964288095536</c:v>
                </c:pt>
                <c:pt idx="2">
                  <c:v>0.418371851598679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63-41E0-886D-85AC9AD1C7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9"/>
        <c:axId val="1953664384"/>
        <c:axId val="1953662304"/>
      </c:barChart>
      <c:catAx>
        <c:axId val="1953664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53662304"/>
        <c:crosses val="autoZero"/>
        <c:auto val="1"/>
        <c:lblAlgn val="ctr"/>
        <c:lblOffset val="100"/>
        <c:noMultiLvlLbl val="0"/>
      </c:catAx>
      <c:valAx>
        <c:axId val="1953662304"/>
        <c:scaling>
          <c:orientation val="minMax"/>
          <c:max val="2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53664384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23_09_26_bar chart (2)'!$C$20:$C$21</c:f>
              <c:strCache>
                <c:ptCount val="2"/>
                <c:pt idx="0">
                  <c:v>163.26</c:v>
                </c:pt>
                <c:pt idx="1">
                  <c:v>E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23_09_26_bar chart (2)'!$E$22:$E$24</c:f>
                <c:numCache>
                  <c:formatCode>General</c:formatCode>
                  <c:ptCount val="3"/>
                  <c:pt idx="0">
                    <c:v>0.17973664767869724</c:v>
                  </c:pt>
                  <c:pt idx="1">
                    <c:v>0.12274866625443613</c:v>
                  </c:pt>
                  <c:pt idx="2">
                    <c:v>3.26367218447348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_09_26_bar chart (2)'!$B$22:$B$24</c:f>
              <c:strCache>
                <c:ptCount val="3"/>
                <c:pt idx="0">
                  <c:v>ca1ca1</c:v>
                </c:pt>
                <c:pt idx="1">
                  <c:v>Ca1ca1</c:v>
                </c:pt>
                <c:pt idx="2">
                  <c:v>Ca1Ca1</c:v>
                </c:pt>
              </c:strCache>
            </c:strRef>
          </c:cat>
          <c:val>
            <c:numRef>
              <c:f>'2023_09_26_bar chart (2)'!$C$22:$C$24</c:f>
              <c:numCache>
                <c:formatCode>General</c:formatCode>
                <c:ptCount val="3"/>
                <c:pt idx="0">
                  <c:v>1.0186257887805117</c:v>
                </c:pt>
                <c:pt idx="1">
                  <c:v>1.062106195213993</c:v>
                </c:pt>
                <c:pt idx="2">
                  <c:v>1.0004745457445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7C-405C-94CB-E1D8C4DFAA34}"/>
            </c:ext>
          </c:extLst>
        </c:ser>
        <c:ser>
          <c:idx val="1"/>
          <c:order val="1"/>
          <c:tx>
            <c:strRef>
              <c:f>'2023_09_26_bar chart (2)'!$D$20:$D$21</c:f>
              <c:strCache>
                <c:ptCount val="2"/>
                <c:pt idx="0">
                  <c:v>163.26</c:v>
                </c:pt>
                <c:pt idx="1">
                  <c:v>Target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23_09_26_bar chart (2)'!$F$22:$F$24</c:f>
                <c:numCache>
                  <c:formatCode>General</c:formatCode>
                  <c:ptCount val="3"/>
                  <c:pt idx="0">
                    <c:v>0.10226309245646738</c:v>
                  </c:pt>
                  <c:pt idx="1">
                    <c:v>0.13337886543719679</c:v>
                  </c:pt>
                  <c:pt idx="2">
                    <c:v>9.118030124059017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_09_26_bar chart (2)'!$B$22:$B$24</c:f>
              <c:strCache>
                <c:ptCount val="3"/>
                <c:pt idx="0">
                  <c:v>ca1ca1</c:v>
                </c:pt>
                <c:pt idx="1">
                  <c:v>Ca1ca1</c:v>
                </c:pt>
                <c:pt idx="2">
                  <c:v>Ca1Ca1</c:v>
                </c:pt>
              </c:strCache>
            </c:strRef>
          </c:cat>
          <c:val>
            <c:numRef>
              <c:f>'2023_09_26_bar chart (2)'!$D$22:$D$24</c:f>
              <c:numCache>
                <c:formatCode>General</c:formatCode>
                <c:ptCount val="3"/>
                <c:pt idx="0">
                  <c:v>0.69699602235090108</c:v>
                </c:pt>
                <c:pt idx="1">
                  <c:v>0.76281476814504545</c:v>
                </c:pt>
                <c:pt idx="2">
                  <c:v>0.73581398499808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7C-405C-94CB-E1D8C4DFAA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9"/>
        <c:axId val="391105920"/>
        <c:axId val="391109664"/>
      </c:barChart>
      <c:catAx>
        <c:axId val="391105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91109664"/>
        <c:crosses val="autoZero"/>
        <c:auto val="1"/>
        <c:lblAlgn val="ctr"/>
        <c:lblOffset val="100"/>
        <c:noMultiLvlLbl val="0"/>
      </c:catAx>
      <c:valAx>
        <c:axId val="391109664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91105920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192756490563997E-2"/>
          <c:y val="7.5799996097345404E-2"/>
          <c:w val="0.8928714866238564"/>
          <c:h val="0.847610951819686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ar chart'!$C$7</c:f>
              <c:strCache>
                <c:ptCount val="1"/>
                <c:pt idx="0">
                  <c:v>E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ar chart'!$E$8:$E$11</c:f>
                <c:numCache>
                  <c:formatCode>General</c:formatCode>
                  <c:ptCount val="4"/>
                  <c:pt idx="0">
                    <c:v>7.5287003840076597E-2</c:v>
                  </c:pt>
                  <c:pt idx="1">
                    <c:v>0.18972130893601893</c:v>
                  </c:pt>
                  <c:pt idx="2">
                    <c:v>9.9654968763509502E-2</c:v>
                  </c:pt>
                  <c:pt idx="3">
                    <c:v>0.116457503752202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ar chart'!$B$8:$B$11</c:f>
              <c:strCache>
                <c:ptCount val="4"/>
                <c:pt idx="0">
                  <c:v>Medallion</c:v>
                </c:pt>
                <c:pt idx="1">
                  <c:v>FL_17.15-86</c:v>
                </c:pt>
                <c:pt idx="2">
                  <c:v>Brilliance</c:v>
                </c:pt>
                <c:pt idx="3">
                  <c:v>Sensation</c:v>
                </c:pt>
              </c:strCache>
            </c:strRef>
          </c:cat>
          <c:val>
            <c:numRef>
              <c:f>'bar chart'!$C$8:$C$11</c:f>
              <c:numCache>
                <c:formatCode>General</c:formatCode>
                <c:ptCount val="4"/>
                <c:pt idx="0">
                  <c:v>1.0748751897393161</c:v>
                </c:pt>
                <c:pt idx="1">
                  <c:v>1.1317980241371448</c:v>
                </c:pt>
                <c:pt idx="2">
                  <c:v>1.0527324720794657</c:v>
                </c:pt>
                <c:pt idx="3">
                  <c:v>1.12834432428158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C9-43CE-9C32-CE551D421FBB}"/>
            </c:ext>
          </c:extLst>
        </c:ser>
        <c:ser>
          <c:idx val="1"/>
          <c:order val="1"/>
          <c:tx>
            <c:strRef>
              <c:f>'bar chart'!$D$7</c:f>
              <c:strCache>
                <c:ptCount val="1"/>
                <c:pt idx="0">
                  <c:v>Targe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ar chart'!$F$8:$F$11</c:f>
                <c:numCache>
                  <c:formatCode>General</c:formatCode>
                  <c:ptCount val="4"/>
                  <c:pt idx="0">
                    <c:v>0.26376819012488267</c:v>
                  </c:pt>
                  <c:pt idx="1">
                    <c:v>0.33377587363278588</c:v>
                  </c:pt>
                  <c:pt idx="2">
                    <c:v>0.18825536464949844</c:v>
                  </c:pt>
                  <c:pt idx="3">
                    <c:v>0.438233642089991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ar chart'!$B$8:$B$11</c:f>
              <c:strCache>
                <c:ptCount val="4"/>
                <c:pt idx="0">
                  <c:v>Medallion</c:v>
                </c:pt>
                <c:pt idx="1">
                  <c:v>FL_17.15-86</c:v>
                </c:pt>
                <c:pt idx="2">
                  <c:v>Brilliance</c:v>
                </c:pt>
                <c:pt idx="3">
                  <c:v>Sensation</c:v>
                </c:pt>
              </c:strCache>
            </c:strRef>
          </c:cat>
          <c:val>
            <c:numRef>
              <c:f>'bar chart'!$D$8:$D$11</c:f>
              <c:numCache>
                <c:formatCode>General</c:formatCode>
                <c:ptCount val="4"/>
                <c:pt idx="0">
                  <c:v>2.6310651438635175</c:v>
                </c:pt>
                <c:pt idx="1">
                  <c:v>2.9501710771301131</c:v>
                </c:pt>
                <c:pt idx="2">
                  <c:v>1.5408577188444648</c:v>
                </c:pt>
                <c:pt idx="3">
                  <c:v>6.87381623298519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C9-43CE-9C32-CE551D421F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9"/>
        <c:axId val="1953664384"/>
        <c:axId val="1953662304"/>
      </c:barChart>
      <c:catAx>
        <c:axId val="1953664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53662304"/>
        <c:crosses val="autoZero"/>
        <c:auto val="1"/>
        <c:lblAlgn val="ctr"/>
        <c:lblOffset val="100"/>
        <c:noMultiLvlLbl val="0"/>
      </c:catAx>
      <c:valAx>
        <c:axId val="1953662304"/>
        <c:scaling>
          <c:orientation val="minMax"/>
          <c:max val="8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5366438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>
          <a:solidFill>
            <a:schemeClr val="tx1"/>
          </a:solidFill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63F6D8-284D-4C3E-A3B1-E091962B8775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ECBCEB-794E-40A3-94C7-269D3780C7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1061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1pPr>
    <a:lvl2pPr marL="1306266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2pPr>
    <a:lvl3pPr marL="2612532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3pPr>
    <a:lvl4pPr marL="3918798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4pPr>
    <a:lvl5pPr marL="5225064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5pPr>
    <a:lvl6pPr marL="6531331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6pPr>
    <a:lvl7pPr marL="7837597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7pPr>
    <a:lvl8pPr marL="9143863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8pPr>
    <a:lvl9pPr marL="10450129" algn="l" defTabSz="2612532" rtl="0" eaLnBrk="1" latinLnBrk="0" hangingPunct="1">
      <a:defRPr sz="342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4489452"/>
            <a:ext cx="15544800" cy="95504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14408152"/>
            <a:ext cx="13716000" cy="6623048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641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320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1460500"/>
            <a:ext cx="3943350" cy="232473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1460500"/>
            <a:ext cx="11601450" cy="2324735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90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785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6838958"/>
            <a:ext cx="15773400" cy="11410948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18357858"/>
            <a:ext cx="15773400" cy="6000748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17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7302500"/>
            <a:ext cx="7772400" cy="174053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7302500"/>
            <a:ext cx="7772400" cy="174053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74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1460506"/>
            <a:ext cx="15773400" cy="53022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6724652"/>
            <a:ext cx="7736680" cy="329564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10020300"/>
            <a:ext cx="7736680" cy="147383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6724652"/>
            <a:ext cx="7774782" cy="329564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10020300"/>
            <a:ext cx="7774782" cy="147383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411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598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92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1828800"/>
            <a:ext cx="5898356" cy="64008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3949706"/>
            <a:ext cx="9258300" cy="1949450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8229600"/>
            <a:ext cx="5898356" cy="15246352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119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1828800"/>
            <a:ext cx="5898356" cy="64008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3949706"/>
            <a:ext cx="9258300" cy="1949450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8229600"/>
            <a:ext cx="5898356" cy="15246352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486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1460506"/>
            <a:ext cx="1577340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7302500"/>
            <a:ext cx="1577340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25425406"/>
            <a:ext cx="41148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9EF46-764C-4085-86EA-B98529160662}" type="datetimeFigureOut">
              <a:rPr lang="en-US" smtClean="0"/>
              <a:t>9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25425406"/>
            <a:ext cx="61722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25425406"/>
            <a:ext cx="41148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4A636-8D58-41AC-A911-652E669D77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08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image" Target="../media/image2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AutoShape 2" descr="https://usc-powerpoint.officeapps.live.com/pods/GetClipboardImage.ashx?Id=9728befd-b9d2-4e07-a8c0-ddcfd5f113fa&amp;DC=PUS9&amp;pkey=53adfc87-d8bb-4b0b-a9f6-72a018b601c2&amp;wdwaccluster=PUS9"/>
          <p:cNvSpPr>
            <a:spLocks noChangeAspect="1" noChangeArrowheads="1"/>
          </p:cNvSpPr>
          <p:nvPr/>
        </p:nvSpPr>
        <p:spPr bwMode="auto">
          <a:xfrm>
            <a:off x="2190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14C6D73-3BD5-B298-A90C-6653C633ED99}"/>
              </a:ext>
            </a:extLst>
          </p:cNvPr>
          <p:cNvGrpSpPr/>
          <p:nvPr/>
        </p:nvGrpSpPr>
        <p:grpSpPr>
          <a:xfrm>
            <a:off x="219075" y="4132920"/>
            <a:ext cx="9237824" cy="13653289"/>
            <a:chOff x="219075" y="4132920"/>
            <a:chExt cx="9237824" cy="1365328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8EED898D-1687-61D9-F672-7BE02D80626D}"/>
                </a:ext>
              </a:extLst>
            </p:cNvPr>
            <p:cNvGrpSpPr/>
            <p:nvPr/>
          </p:nvGrpSpPr>
          <p:grpSpPr>
            <a:xfrm>
              <a:off x="321227" y="11762150"/>
              <a:ext cx="9135672" cy="6024059"/>
              <a:chOff x="149860" y="13730737"/>
              <a:chExt cx="9135672" cy="6024059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A1A153F7-55EF-2A19-9345-B6ADB1959153}"/>
                  </a:ext>
                </a:extLst>
              </p:cNvPr>
              <p:cNvSpPr txBox="1"/>
              <p:nvPr/>
            </p:nvSpPr>
            <p:spPr>
              <a:xfrm rot="10800000">
                <a:off x="149860" y="14039725"/>
                <a:ext cx="923331" cy="482828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Relative expression level</a:t>
                </a:r>
              </a:p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(</a:t>
                </a:r>
                <a:r>
                  <a:rPr lang="en-US" sz="2400" b="1" dirty="0" err="1">
                    <a:cs typeface="Times New Roman" panose="02020603050405020304" pitchFamily="18" charset="0"/>
                  </a:rPr>
                  <a:t>Log₂FC</a:t>
                </a:r>
                <a:r>
                  <a:rPr lang="en-US" sz="2400" b="1" dirty="0">
                    <a:cs typeface="Times New Roman" panose="02020603050405020304" pitchFamily="18" charset="0"/>
                  </a:rPr>
                  <a:t>)</a:t>
                </a:r>
              </a:p>
            </p:txBody>
          </p:sp>
          <p:graphicFrame>
            <p:nvGraphicFramePr>
              <p:cNvPr id="53" name="Chart 52">
                <a:extLst>
                  <a:ext uri="{FF2B5EF4-FFF2-40B4-BE49-F238E27FC236}">
                    <a16:creationId xmlns:a16="http://schemas.microsoft.com/office/drawing/2014/main" id="{50A6F884-9B6C-47D1-B28F-1EFBDA0E1F8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53588743"/>
                  </p:ext>
                </p:extLst>
              </p:nvPr>
            </p:nvGraphicFramePr>
            <p:xfrm>
              <a:off x="1397107" y="14572110"/>
              <a:ext cx="7564510" cy="506332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BE621392-BCD4-38F6-DFF7-74C4F6D72D1A}"/>
                  </a:ext>
                </a:extLst>
              </p:cNvPr>
              <p:cNvGrpSpPr/>
              <p:nvPr/>
            </p:nvGrpSpPr>
            <p:grpSpPr>
              <a:xfrm>
                <a:off x="6460838" y="13730737"/>
                <a:ext cx="2338821" cy="889446"/>
                <a:chOff x="6593299" y="13593761"/>
                <a:chExt cx="2338821" cy="889446"/>
              </a:xfrm>
            </p:grpSpPr>
            <p:pic>
              <p:nvPicPr>
                <p:cNvPr id="8" name="Picture 18">
                  <a:extLst>
                    <a:ext uri="{FF2B5EF4-FFF2-40B4-BE49-F238E27FC236}">
                      <a16:creationId xmlns:a16="http://schemas.microsoft.com/office/drawing/2014/main" id="{FB60FC9C-2A30-E7B4-CB53-0540CBCDDA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7756" t="23158" r="83235" b="63061"/>
                <a:stretch/>
              </p:blipFill>
              <p:spPr>
                <a:xfrm>
                  <a:off x="6593299" y="13596938"/>
                  <a:ext cx="398051" cy="418587"/>
                </a:xfrm>
                <a:prstGeom prst="rect">
                  <a:avLst/>
                </a:prstGeom>
              </p:spPr>
            </p:pic>
            <p:pic>
              <p:nvPicPr>
                <p:cNvPr id="57" name="Picture 18">
                  <a:extLst>
                    <a:ext uri="{FF2B5EF4-FFF2-40B4-BE49-F238E27FC236}">
                      <a16:creationId xmlns:a16="http://schemas.microsoft.com/office/drawing/2014/main" id="{E3D15624-E3C5-F4CA-DC44-5E778C2239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8295" t="40818" r="82696" b="44473"/>
                <a:stretch/>
              </p:blipFill>
              <p:spPr>
                <a:xfrm>
                  <a:off x="6593299" y="14064620"/>
                  <a:ext cx="398051" cy="418587"/>
                </a:xfrm>
                <a:prstGeom prst="rect">
                  <a:avLst/>
                </a:prstGeom>
              </p:spPr>
            </p:pic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FC9CAE50-A21A-9927-0CB3-A160996BB545}"/>
                    </a:ext>
                  </a:extLst>
                </p:cNvPr>
                <p:cNvSpPr txBox="1"/>
                <p:nvPr/>
              </p:nvSpPr>
              <p:spPr>
                <a:xfrm>
                  <a:off x="6961343" y="13593761"/>
                  <a:ext cx="196849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Empty Vector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354EA1AB-BDEC-3B78-60F3-7B1B8773D7E3}"/>
                    </a:ext>
                  </a:extLst>
                </p:cNvPr>
                <p:cNvSpPr txBox="1"/>
                <p:nvPr/>
              </p:nvSpPr>
              <p:spPr>
                <a:xfrm>
                  <a:off x="6963621" y="14045022"/>
                  <a:ext cx="196849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pK7::</a:t>
                  </a:r>
                  <a:r>
                    <a:rPr lang="en-US" sz="2000" b="1" i="1" dirty="0"/>
                    <a:t>FaLRK10B</a:t>
                  </a:r>
                  <a:endParaRPr lang="en-US" sz="2000" b="1" dirty="0"/>
                </a:p>
              </p:txBody>
            </p:sp>
          </p:grp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8F410F2E-BEBE-CB7E-070B-88E6301B72FD}"/>
                  </a:ext>
                </a:extLst>
              </p:cNvPr>
              <p:cNvSpPr txBox="1"/>
              <p:nvPr/>
            </p:nvSpPr>
            <p:spPr>
              <a:xfrm>
                <a:off x="2211724" y="19139243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 16.74-68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98119CC-F622-CF2F-5434-E6B483A838B6}"/>
                  </a:ext>
                </a:extLst>
              </p:cNvPr>
              <p:cNvSpPr txBox="1"/>
              <p:nvPr/>
            </p:nvSpPr>
            <p:spPr>
              <a:xfrm>
                <a:off x="4580041" y="19139242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orida Brilliance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302ECE6F-9780-EBA1-3F8B-8E00DB1E4803}"/>
                  </a:ext>
                </a:extLst>
              </p:cNvPr>
              <p:cNvSpPr txBox="1"/>
              <p:nvPr/>
            </p:nvSpPr>
            <p:spPr>
              <a:xfrm>
                <a:off x="6722734" y="19139242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 17.20-51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3DFDAA73-979B-49C4-E593-68DD9CE22D89}"/>
                  </a:ext>
                </a:extLst>
              </p:cNvPr>
              <p:cNvSpPr txBox="1"/>
              <p:nvPr/>
            </p:nvSpPr>
            <p:spPr>
              <a:xfrm>
                <a:off x="7898533" y="17208448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CE80CC6-B8FA-4905-C478-EE31DC07F489}"/>
                  </a:ext>
                </a:extLst>
              </p:cNvPr>
              <p:cNvSpPr txBox="1"/>
              <p:nvPr/>
            </p:nvSpPr>
            <p:spPr>
              <a:xfrm>
                <a:off x="5634860" y="15964872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FCD60C59-B398-8C04-8054-5C5C6DD8A201}"/>
                  </a:ext>
                </a:extLst>
              </p:cNvPr>
              <p:cNvSpPr txBox="1"/>
              <p:nvPr/>
            </p:nvSpPr>
            <p:spPr>
              <a:xfrm>
                <a:off x="3278194" y="16899752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**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E546A12-FB57-F8A6-A91A-557AAB5BF294}"/>
                </a:ext>
              </a:extLst>
            </p:cNvPr>
            <p:cNvGrpSpPr/>
            <p:nvPr/>
          </p:nvGrpSpPr>
          <p:grpSpPr>
            <a:xfrm>
              <a:off x="219075" y="5005215"/>
              <a:ext cx="8839275" cy="5752431"/>
              <a:chOff x="62209" y="7545215"/>
              <a:chExt cx="8839275" cy="575243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E8E1DC5-62E1-F70C-F337-66CA6484E017}"/>
                  </a:ext>
                </a:extLst>
              </p:cNvPr>
              <p:cNvSpPr txBox="1"/>
              <p:nvPr/>
            </p:nvSpPr>
            <p:spPr>
              <a:xfrm rot="10800000">
                <a:off x="62209" y="8197962"/>
                <a:ext cx="923331" cy="449142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Relative expression level</a:t>
                </a:r>
              </a:p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(</a:t>
                </a:r>
                <a:r>
                  <a:rPr lang="en-US" sz="2400" b="1" dirty="0" err="1">
                    <a:cs typeface="Times New Roman" panose="02020603050405020304" pitchFamily="18" charset="0"/>
                  </a:rPr>
                  <a:t>Log₂FC</a:t>
                </a:r>
                <a:r>
                  <a:rPr lang="en-US" sz="2400" b="1" dirty="0">
                    <a:cs typeface="Times New Roman" panose="02020603050405020304" pitchFamily="18" charset="0"/>
                  </a:rPr>
                  <a:t>)</a:t>
                </a:r>
              </a:p>
            </p:txBody>
          </p:sp>
          <p:graphicFrame>
            <p:nvGraphicFramePr>
              <p:cNvPr id="48" name="Chart 47">
                <a:extLst>
                  <a:ext uri="{FF2B5EF4-FFF2-40B4-BE49-F238E27FC236}">
                    <a16:creationId xmlns:a16="http://schemas.microsoft.com/office/drawing/2014/main" id="{F4989FDF-1C00-4C6B-99A7-B7096A196C8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63107379"/>
                  </p:ext>
                </p:extLst>
              </p:nvPr>
            </p:nvGraphicFramePr>
            <p:xfrm>
              <a:off x="1142896" y="7713678"/>
              <a:ext cx="7698455" cy="52008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950B496-23D5-CD3B-3222-702B1749764A}"/>
                  </a:ext>
                </a:extLst>
              </p:cNvPr>
              <p:cNvSpPr txBox="1"/>
              <p:nvPr/>
            </p:nvSpPr>
            <p:spPr>
              <a:xfrm>
                <a:off x="2082290" y="12682093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 16.74-68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44E3D37-AAF9-BBF0-620B-EFF173A5461E}"/>
                  </a:ext>
                </a:extLst>
              </p:cNvPr>
              <p:cNvSpPr txBox="1"/>
              <p:nvPr/>
            </p:nvSpPr>
            <p:spPr>
              <a:xfrm>
                <a:off x="4450607" y="12682092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orida Brilliance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052C7CF-CE06-FB8E-47F5-1B397ADA815C}"/>
                  </a:ext>
                </a:extLst>
              </p:cNvPr>
              <p:cNvSpPr txBox="1"/>
              <p:nvPr/>
            </p:nvSpPr>
            <p:spPr>
              <a:xfrm>
                <a:off x="6593300" y="12682092"/>
                <a:ext cx="1977895" cy="615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FL 17.20-51</a:t>
                </a:r>
              </a:p>
              <a:p>
                <a:pPr algn="ctr"/>
                <a:r>
                  <a:rPr lang="en-US" sz="2000" b="1" i="1" dirty="0">
                    <a:cs typeface="Arial" panose="020B0604020202020204" pitchFamily="34" charset="0"/>
                  </a:rPr>
                  <a:t>Ca1Ca1</a:t>
                </a:r>
              </a:p>
            </p:txBody>
          </p: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3F4F076B-8E3A-0841-148D-9DC05188F80C}"/>
                  </a:ext>
                </a:extLst>
              </p:cNvPr>
              <p:cNvGrpSpPr/>
              <p:nvPr/>
            </p:nvGrpSpPr>
            <p:grpSpPr>
              <a:xfrm>
                <a:off x="6300330" y="7545215"/>
                <a:ext cx="2474301" cy="990176"/>
                <a:chOff x="6743701" y="7518033"/>
                <a:chExt cx="2474301" cy="990176"/>
              </a:xfrm>
            </p:grpSpPr>
            <p:pic>
              <p:nvPicPr>
                <p:cNvPr id="7" name="Picture 13">
                  <a:extLst>
                    <a:ext uri="{FF2B5EF4-FFF2-40B4-BE49-F238E27FC236}">
                      <a16:creationId xmlns:a16="http://schemas.microsoft.com/office/drawing/2014/main" id="{E8CEA5C1-5962-8848-5BC3-6A14042216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7417" t="30816" r="82423" b="14117"/>
                <a:stretch/>
              </p:blipFill>
              <p:spPr>
                <a:xfrm>
                  <a:off x="6743701" y="7518033"/>
                  <a:ext cx="431800" cy="984487"/>
                </a:xfrm>
                <a:prstGeom prst="rect">
                  <a:avLst/>
                </a:prstGeom>
              </p:spPr>
            </p:pic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2F552ACC-B2AD-1A14-A88C-D2C5FF2C0AD8}"/>
                    </a:ext>
                  </a:extLst>
                </p:cNvPr>
                <p:cNvSpPr txBox="1"/>
                <p:nvPr/>
              </p:nvSpPr>
              <p:spPr>
                <a:xfrm>
                  <a:off x="7175501" y="8108099"/>
                  <a:ext cx="196849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pK7::</a:t>
                  </a:r>
                  <a:r>
                    <a:rPr lang="en-US" sz="2000" b="1" i="1" dirty="0"/>
                    <a:t>FaLRK10A</a:t>
                  </a:r>
                  <a:endParaRPr lang="en-US" sz="2000" b="1" dirty="0"/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AACE1DC0-87AA-EFA9-F055-7E9FA2FBE930}"/>
                    </a:ext>
                  </a:extLst>
                </p:cNvPr>
                <p:cNvSpPr txBox="1"/>
                <p:nvPr/>
              </p:nvSpPr>
              <p:spPr>
                <a:xfrm>
                  <a:off x="7249503" y="7634728"/>
                  <a:ext cx="196849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Empty Vector</a:t>
                  </a:r>
                </a:p>
              </p:txBody>
            </p:sp>
          </p:grp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D6178486-88B7-F18B-A0B4-6101E1D2C2B3}"/>
                  </a:ext>
                </a:extLst>
              </p:cNvPr>
              <p:cNvSpPr txBox="1"/>
              <p:nvPr/>
            </p:nvSpPr>
            <p:spPr>
              <a:xfrm>
                <a:off x="7514485" y="10170667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**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529D6C50-813B-3DBD-F59E-11E771428216}"/>
                  </a:ext>
                </a:extLst>
              </p:cNvPr>
              <p:cNvSpPr txBox="1"/>
              <p:nvPr/>
            </p:nvSpPr>
            <p:spPr>
              <a:xfrm>
                <a:off x="5404763" y="9956721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4A5CBC75-8BCE-CAD0-2D20-1B6EADB79DE0}"/>
                  </a:ext>
                </a:extLst>
              </p:cNvPr>
              <p:cNvSpPr txBox="1"/>
              <p:nvPr/>
            </p:nvSpPr>
            <p:spPr>
              <a:xfrm>
                <a:off x="3056021" y="10243890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**</a:t>
                </a:r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A432A7B-513E-C38A-1038-1717FA7B402B}"/>
                </a:ext>
              </a:extLst>
            </p:cNvPr>
            <p:cNvSpPr txBox="1"/>
            <p:nvPr/>
          </p:nvSpPr>
          <p:spPr>
            <a:xfrm>
              <a:off x="321226" y="4132920"/>
              <a:ext cx="219282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/>
                <a:t>A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E851932-DCD7-4E8D-514D-556793D15EA7}"/>
              </a:ext>
            </a:extLst>
          </p:cNvPr>
          <p:cNvGrpSpPr/>
          <p:nvPr/>
        </p:nvGrpSpPr>
        <p:grpSpPr>
          <a:xfrm>
            <a:off x="9118484" y="7397243"/>
            <a:ext cx="9609970" cy="7548565"/>
            <a:chOff x="9118484" y="7397243"/>
            <a:chExt cx="9609970" cy="7548565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94B15993-99A6-5A89-D918-9712E67BB9BA}"/>
                </a:ext>
              </a:extLst>
            </p:cNvPr>
            <p:cNvGrpSpPr/>
            <p:nvPr/>
          </p:nvGrpSpPr>
          <p:grpSpPr>
            <a:xfrm>
              <a:off x="9118484" y="8067705"/>
              <a:ext cx="9609970" cy="6878103"/>
              <a:chOff x="9118484" y="8067705"/>
              <a:chExt cx="9609970" cy="6878103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C43067C-54C6-7DBA-A0D4-817AABBB6114}"/>
                  </a:ext>
                </a:extLst>
              </p:cNvPr>
              <p:cNvSpPr txBox="1"/>
              <p:nvPr/>
            </p:nvSpPr>
            <p:spPr>
              <a:xfrm rot="10800000">
                <a:off x="9118484" y="8718552"/>
                <a:ext cx="923330" cy="521831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Relative expression level</a:t>
                </a:r>
              </a:p>
              <a:p>
                <a:pPr algn="ctr"/>
                <a:r>
                  <a:rPr lang="en-US" sz="2400" b="1" dirty="0">
                    <a:cs typeface="Times New Roman" panose="02020603050405020304" pitchFamily="18" charset="0"/>
                  </a:rPr>
                  <a:t>(</a:t>
                </a:r>
                <a:r>
                  <a:rPr lang="en-US" sz="2400" b="1" dirty="0" err="1">
                    <a:cs typeface="Times New Roman" panose="02020603050405020304" pitchFamily="18" charset="0"/>
                  </a:rPr>
                  <a:t>Log₂FC</a:t>
                </a:r>
                <a:r>
                  <a:rPr lang="en-US" sz="2400" b="1" dirty="0">
                    <a:cs typeface="Times New Roman" panose="02020603050405020304" pitchFamily="18" charset="0"/>
                  </a:rPr>
                  <a:t>)</a:t>
                </a:r>
              </a:p>
            </p:txBody>
          </p: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9DFD0A54-9453-94E4-91A3-76D41616D9AA}"/>
                  </a:ext>
                </a:extLst>
              </p:cNvPr>
              <p:cNvGrpSpPr/>
              <p:nvPr/>
            </p:nvGrpSpPr>
            <p:grpSpPr>
              <a:xfrm>
                <a:off x="10209079" y="8718552"/>
                <a:ext cx="8400141" cy="6227256"/>
                <a:chOff x="9764252" y="11361196"/>
                <a:chExt cx="8400141" cy="6227256"/>
              </a:xfrm>
            </p:grpSpPr>
            <p:graphicFrame>
              <p:nvGraphicFramePr>
                <p:cNvPr id="21" name="Chart 20">
                  <a:extLst>
                    <a:ext uri="{FF2B5EF4-FFF2-40B4-BE49-F238E27FC236}">
                      <a16:creationId xmlns:a16="http://schemas.microsoft.com/office/drawing/2014/main" id="{616112AD-6B54-3240-48B7-FF0C8A6C46E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70661576"/>
                    </p:ext>
                  </p:extLst>
                </p:nvPr>
              </p:nvGraphicFramePr>
              <p:xfrm>
                <a:off x="9764252" y="11361196"/>
                <a:ext cx="8400141" cy="59436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C985950A-CD0F-7D41-88C4-B0B7B5B0E364}"/>
                    </a:ext>
                  </a:extLst>
                </p:cNvPr>
                <p:cNvSpPr txBox="1"/>
                <p:nvPr/>
              </p:nvSpPr>
              <p:spPr>
                <a:xfrm>
                  <a:off x="12163588" y="16972899"/>
                  <a:ext cx="1977895" cy="61555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FL 17.15-86</a:t>
                  </a:r>
                </a:p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ca1ca1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8A3B033A-279D-3E05-FE8D-6917867563F8}"/>
                    </a:ext>
                  </a:extLst>
                </p:cNvPr>
                <p:cNvSpPr txBox="1"/>
                <p:nvPr/>
              </p:nvSpPr>
              <p:spPr>
                <a:xfrm>
                  <a:off x="10185693" y="16935760"/>
                  <a:ext cx="1977895" cy="61555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FL Medallion</a:t>
                  </a:r>
                </a:p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ca1ca1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ACC081D6-3807-D7A1-AEDB-3FAAFC87698D}"/>
                    </a:ext>
                  </a:extLst>
                </p:cNvPr>
                <p:cNvSpPr txBox="1"/>
                <p:nvPr/>
              </p:nvSpPr>
              <p:spPr>
                <a:xfrm>
                  <a:off x="15631056" y="16932148"/>
                  <a:ext cx="1977895" cy="61555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Sensation</a:t>
                  </a:r>
                </a:p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Ca1ca1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59F0CC7B-8A76-BFE8-CF90-7CA40C62334E}"/>
                    </a:ext>
                  </a:extLst>
                </p:cNvPr>
                <p:cNvSpPr txBox="1"/>
                <p:nvPr/>
              </p:nvSpPr>
              <p:spPr>
                <a:xfrm>
                  <a:off x="14023771" y="16932148"/>
                  <a:ext cx="1977895" cy="61555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FL Brilliance</a:t>
                  </a:r>
                </a:p>
                <a:p>
                  <a:pPr algn="ctr"/>
                  <a:r>
                    <a:rPr lang="en-US" sz="2000" b="1" i="1" dirty="0">
                      <a:cs typeface="Arial" panose="020B0604020202020204" pitchFamily="34" charset="0"/>
                    </a:rPr>
                    <a:t>Ca1ca1</a:t>
                  </a: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F9FABD7C-4044-81FD-62EC-59D7429FE407}"/>
                  </a:ext>
                </a:extLst>
              </p:cNvPr>
              <p:cNvGrpSpPr/>
              <p:nvPr/>
            </p:nvGrpSpPr>
            <p:grpSpPr>
              <a:xfrm>
                <a:off x="14586310" y="8067705"/>
                <a:ext cx="3020014" cy="886269"/>
                <a:chOff x="14429444" y="10607705"/>
                <a:chExt cx="3020014" cy="886269"/>
              </a:xfrm>
            </p:grpSpPr>
            <p:pic>
              <p:nvPicPr>
                <p:cNvPr id="61" name="Picture 18">
                  <a:extLst>
                    <a:ext uri="{FF2B5EF4-FFF2-40B4-BE49-F238E27FC236}">
                      <a16:creationId xmlns:a16="http://schemas.microsoft.com/office/drawing/2014/main" id="{4BC545D3-A5DF-3789-35C1-AFD5F6656C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7756" t="23158" r="83235" b="63061"/>
                <a:stretch/>
              </p:blipFill>
              <p:spPr>
                <a:xfrm>
                  <a:off x="14429444" y="10607705"/>
                  <a:ext cx="398051" cy="418587"/>
                </a:xfrm>
                <a:prstGeom prst="rect">
                  <a:avLst/>
                </a:prstGeom>
              </p:spPr>
            </p:pic>
            <p:pic>
              <p:nvPicPr>
                <p:cNvPr id="62" name="Picture 18">
                  <a:extLst>
                    <a:ext uri="{FF2B5EF4-FFF2-40B4-BE49-F238E27FC236}">
                      <a16:creationId xmlns:a16="http://schemas.microsoft.com/office/drawing/2014/main" id="{B2A67C58-853B-9E9B-92E7-8BEE6D56ED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8295" t="40818" r="82696" b="44473"/>
                <a:stretch/>
              </p:blipFill>
              <p:spPr>
                <a:xfrm>
                  <a:off x="14429444" y="11075387"/>
                  <a:ext cx="398051" cy="418587"/>
                </a:xfrm>
                <a:prstGeom prst="rect">
                  <a:avLst/>
                </a:prstGeom>
              </p:spPr>
            </p:pic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FBDBC8A9-D9D0-A181-1ABE-43C9987AA305}"/>
                    </a:ext>
                  </a:extLst>
                </p:cNvPr>
                <p:cNvSpPr txBox="1"/>
                <p:nvPr/>
              </p:nvSpPr>
              <p:spPr>
                <a:xfrm>
                  <a:off x="14870581" y="10629353"/>
                  <a:ext cx="1968499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Empty Vector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CD79AF26-EBA5-9BC9-B931-99DD4F78B4CC}"/>
                    </a:ext>
                  </a:extLst>
                </p:cNvPr>
                <p:cNvSpPr txBox="1"/>
                <p:nvPr/>
              </p:nvSpPr>
              <p:spPr>
                <a:xfrm>
                  <a:off x="14870580" y="11026292"/>
                  <a:ext cx="257887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/>
                    <a:t>pMDC83::</a:t>
                  </a:r>
                  <a:r>
                    <a:rPr lang="en-US" sz="2000" b="1" i="1" dirty="0"/>
                    <a:t>FaLRK10B</a:t>
                  </a:r>
                  <a:endParaRPr lang="en-US" sz="2000" b="1" dirty="0"/>
                </a:p>
              </p:txBody>
            </p:sp>
          </p:grp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A39D0AB1-C1DD-167F-879A-7C01922EA5A4}"/>
                  </a:ext>
                </a:extLst>
              </p:cNvPr>
              <p:cNvSpPr txBox="1"/>
              <p:nvPr/>
            </p:nvSpPr>
            <p:spPr>
              <a:xfrm>
                <a:off x="11709901" y="11612501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4DA202C4-D725-AA3B-5C98-20C946124871}"/>
                  </a:ext>
                </a:extLst>
              </p:cNvPr>
              <p:cNvSpPr txBox="1"/>
              <p:nvPr/>
            </p:nvSpPr>
            <p:spPr>
              <a:xfrm>
                <a:off x="13384710" y="11590847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**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BF97908-8EED-C23D-6481-240D46D34B68}"/>
                  </a:ext>
                </a:extLst>
              </p:cNvPr>
              <p:cNvSpPr txBox="1"/>
              <p:nvPr/>
            </p:nvSpPr>
            <p:spPr>
              <a:xfrm>
                <a:off x="15457545" y="12410264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C8CAB74-D8C3-529E-BCEC-935FA1492183}"/>
                  </a:ext>
                </a:extLst>
              </p:cNvPr>
              <p:cNvSpPr txBox="1"/>
              <p:nvPr/>
            </p:nvSpPr>
            <p:spPr>
              <a:xfrm>
                <a:off x="17341455" y="9113448"/>
                <a:ext cx="13869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600" b="1" dirty="0"/>
                  <a:t>*</a:t>
                </a: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71DDDBD-CE83-EA09-9B46-E0FD42F48E2C}"/>
                </a:ext>
              </a:extLst>
            </p:cNvPr>
            <p:cNvSpPr txBox="1"/>
            <p:nvPr/>
          </p:nvSpPr>
          <p:spPr>
            <a:xfrm>
              <a:off x="9456899" y="7397243"/>
              <a:ext cx="219282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56488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EACD48D9E88B44A247F94DFCC5AD14" ma:contentTypeVersion="17" ma:contentTypeDescription="Create a new document." ma:contentTypeScope="" ma:versionID="3bfc92cda140e26d842e5349fc92a0d8">
  <xsd:schema xmlns:xsd="http://www.w3.org/2001/XMLSchema" xmlns:xs="http://www.w3.org/2001/XMLSchema" xmlns:p="http://schemas.microsoft.com/office/2006/metadata/properties" xmlns:ns2="b59ca574-8d5d-4f55-bee3-22f9424b76c1" xmlns:ns3="e567e6bd-c66f-447b-b581-a97dbc0e6a19" targetNamespace="http://schemas.microsoft.com/office/2006/metadata/properties" ma:root="true" ma:fieldsID="ddb2211cce4e0248569cf220309bbb9a" ns2:_="" ns3:_="">
    <xsd:import namespace="b59ca574-8d5d-4f55-bee3-22f9424b76c1"/>
    <xsd:import namespace="e567e6bd-c66f-447b-b581-a97dbc0e6a1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59ca574-8d5d-4f55-bee3-22f9424b76c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a0c477a-f09e-4137-8c49-77869fdcca9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LengthInSeconds" ma:index="24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67e6bd-c66f-447b-b581-a97dbc0e6a19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06c87a9-14b5-480d-a4b3-c4a5177fbe6d}" ma:internalName="TaxCatchAll" ma:showField="CatchAllData" ma:web="e567e6bd-c66f-447b-b581-a97dbc0e6a1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59ca574-8d5d-4f55-bee3-22f9424b76c1">
      <Terms xmlns="http://schemas.microsoft.com/office/infopath/2007/PartnerControls"/>
    </lcf76f155ced4ddcb4097134ff3c332f>
    <TaxCatchAll xmlns="e567e6bd-c66f-447b-b581-a97dbc0e6a19" xsi:nil="true"/>
  </documentManagement>
</p:properties>
</file>

<file path=customXml/itemProps1.xml><?xml version="1.0" encoding="utf-8"?>
<ds:datastoreItem xmlns:ds="http://schemas.openxmlformats.org/officeDocument/2006/customXml" ds:itemID="{25A30969-303A-43B4-BB06-E248EC5CDFF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59ca574-8d5d-4f55-bee3-22f9424b76c1"/>
    <ds:schemaRef ds:uri="e567e6bd-c66f-447b-b581-a97dbc0e6a1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3258552-5609-4E70-93E3-AB612F23A40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11E3E94-ACD5-4B99-B863-9A99D2BA8E32}">
  <ds:schemaRefs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0bd71c54-e13f-40b0-9fba-bef6f4fb2a15"/>
    <ds:schemaRef ds:uri="d9cc57c6-51ee-422e-a2ea-072becafe7d8"/>
    <ds:schemaRef ds:uri="http://purl.org/dc/terms/"/>
    <ds:schemaRef ds:uri="http://www.w3.org/XML/1998/namespace"/>
    <ds:schemaRef ds:uri="http://purl.org/dc/dcmitype/"/>
    <ds:schemaRef ds:uri="b59ca574-8d5d-4f55-bee3-22f9424b76c1"/>
    <ds:schemaRef ds:uri="e567e6bd-c66f-447b-b581-a97dbc0e6a19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31</TotalTime>
  <Words>80</Words>
  <Application>Microsoft Office PowerPoint</Application>
  <PresentationFormat>사용자 지정</PresentationFormat>
  <Paragraphs>4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g, Yoon Jeong</dc:creator>
  <cp:lastModifiedBy>Yoon Jeong Jang</cp:lastModifiedBy>
  <cp:revision>45</cp:revision>
  <dcterms:created xsi:type="dcterms:W3CDTF">2023-01-05T19:55:29Z</dcterms:created>
  <dcterms:modified xsi:type="dcterms:W3CDTF">2024-09-30T09:02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EACD48D9E88B44A247F94DFCC5AD14</vt:lpwstr>
  </property>
</Properties>
</file>